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drawings/drawing8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8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file:///C:\Users\y-abe581\Desktop\JODAN3\20221222\&#21508;&#24180;&#27598;&#12392;2020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5" Type="http://schemas.openxmlformats.org/officeDocument/2006/relationships/chartUserShapes" Target="../drawings/drawing2.xml"/><Relationship Id="rId4" Type="http://schemas.openxmlformats.org/officeDocument/2006/relationships/oleObject" Target="file:///C:\Users\y-abe581\Desktop\JODAN3\20221222\&#21508;&#24180;&#27598;&#12392;2020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5" Type="http://schemas.openxmlformats.org/officeDocument/2006/relationships/chartUserShapes" Target="../drawings/drawing3.xml"/><Relationship Id="rId4" Type="http://schemas.openxmlformats.org/officeDocument/2006/relationships/oleObject" Target="file:///C:\Users\y-abe581\Desktop\JODAN3\20221222\&#21508;&#24180;&#27598;&#12392;2020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5" Type="http://schemas.openxmlformats.org/officeDocument/2006/relationships/chartUserShapes" Target="../drawings/drawing4.xml"/><Relationship Id="rId4" Type="http://schemas.openxmlformats.org/officeDocument/2006/relationships/oleObject" Target="file:///C:\Users\y-abe581\Desktop\JODAN3\20221222\&#21508;&#24180;&#27598;&#12392;2020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5" Type="http://schemas.openxmlformats.org/officeDocument/2006/relationships/chartUserShapes" Target="../drawings/drawing5.xml"/><Relationship Id="rId4" Type="http://schemas.openxmlformats.org/officeDocument/2006/relationships/oleObject" Target="file:///C:\Users\y-abe581\Desktop\JODAN3\20221222\&#21508;&#24180;&#27598;&#12392;2020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5" Type="http://schemas.openxmlformats.org/officeDocument/2006/relationships/chartUserShapes" Target="../drawings/drawing6.xml"/><Relationship Id="rId4" Type="http://schemas.openxmlformats.org/officeDocument/2006/relationships/oleObject" Target="file:///C:\Users\y-abe581\Desktop\JODAN3\20221222\&#21508;&#24180;&#27598;&#12392;2020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5" Type="http://schemas.openxmlformats.org/officeDocument/2006/relationships/chartUserShapes" Target="../drawings/drawing7.xml"/><Relationship Id="rId4" Type="http://schemas.openxmlformats.org/officeDocument/2006/relationships/oleObject" Target="file:///C:\Users\y-abe581\Desktop\JODAN3\20221222\&#21508;&#24180;&#27598;&#12392;2020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5" Type="http://schemas.openxmlformats.org/officeDocument/2006/relationships/chartUserShapes" Target="../drawings/drawing8.xml"/><Relationship Id="rId4" Type="http://schemas.openxmlformats.org/officeDocument/2006/relationships/oleObject" Target="file:///C:\Users\y-abe581\Desktop\JODAN3\20221222\&#21508;&#24180;&#27598;&#12392;20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>
                <a:solidFill>
                  <a:sysClr val="windowText" lastClr="000000"/>
                </a:solidFill>
              </a:rPr>
              <a:t>HD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C$5</c:f>
              <c:strCache>
                <c:ptCount val="1"/>
                <c:pt idx="0">
                  <c:v>aOR</c:v>
                </c:pt>
              </c:strCache>
            </c:strRef>
          </c:tx>
          <c:spPr>
            <a:ln w="28575" cap="rnd">
              <a:noFill/>
              <a:bevel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G$6:$G$10</c:f>
                <c:numCache>
                  <c:formatCode>General</c:formatCode>
                  <c:ptCount val="5"/>
                  <c:pt idx="0">
                    <c:v>3.0000000000000027E-2</c:v>
                  </c:pt>
                  <c:pt idx="1">
                    <c:v>3.2000000000000028E-2</c:v>
                  </c:pt>
                  <c:pt idx="2">
                    <c:v>3.2000000000000028E-2</c:v>
                  </c:pt>
                  <c:pt idx="3">
                    <c:v>3.2999999999999918E-2</c:v>
                  </c:pt>
                  <c:pt idx="4">
                    <c:v>2.6000000000000023E-2</c:v>
                  </c:pt>
                </c:numCache>
              </c:numRef>
            </c:plus>
            <c:minus>
              <c:numRef>
                <c:f>Sheet1!$E$6:$E$10</c:f>
                <c:numCache>
                  <c:formatCode>General</c:formatCode>
                  <c:ptCount val="5"/>
                  <c:pt idx="0">
                    <c:v>2.9000000000000026E-2</c:v>
                  </c:pt>
                  <c:pt idx="1">
                    <c:v>3.0000000000000027E-2</c:v>
                  </c:pt>
                  <c:pt idx="2">
                    <c:v>3.1000000000000139E-2</c:v>
                  </c:pt>
                  <c:pt idx="3">
                    <c:v>3.0999999999999917E-2</c:v>
                  </c:pt>
                  <c:pt idx="4">
                    <c:v>2.400000000000002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6:$A$10</c:f>
              <c:strCache>
                <c:ptCount val="5"/>
                <c:pt idx="0">
                  <c:v>2020 vs 2019</c:v>
                </c:pt>
                <c:pt idx="1">
                  <c:v>2020 vs 2018</c:v>
                </c:pt>
                <c:pt idx="2">
                  <c:v>2020 vs 2017</c:v>
                </c:pt>
                <c:pt idx="3">
                  <c:v>2020 vs 2016</c:v>
                </c:pt>
                <c:pt idx="4">
                  <c:v>2020 vs 2016-2019</c:v>
                </c:pt>
              </c:strCache>
            </c:strRef>
          </c:cat>
          <c:val>
            <c:numRef>
              <c:f>Sheet1!$C$6:$C$10</c:f>
              <c:numCache>
                <c:formatCode>General</c:formatCode>
                <c:ptCount val="5"/>
                <c:pt idx="0">
                  <c:v>1.024</c:v>
                </c:pt>
                <c:pt idx="1">
                  <c:v>1.0740000000000001</c:v>
                </c:pt>
                <c:pt idx="2">
                  <c:v>1.0660000000000001</c:v>
                </c:pt>
                <c:pt idx="3">
                  <c:v>1.095</c:v>
                </c:pt>
                <c:pt idx="4">
                  <c:v>1.064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812-4DB1-8598-15A05A6DB6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58615200"/>
        <c:axId val="1039151968"/>
      </c:lineChart>
      <c:catAx>
        <c:axId val="1458615200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39151968"/>
        <c:crosses val="autoZero"/>
        <c:auto val="1"/>
        <c:lblAlgn val="ctr"/>
        <c:lblOffset val="100"/>
        <c:noMultiLvlLbl val="0"/>
      </c:catAx>
      <c:valAx>
        <c:axId val="103915196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5861520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ja-JP" dirty="0">
                <a:solidFill>
                  <a:schemeClr val="tx1"/>
                </a:solidFill>
              </a:rPr>
              <a:t>FGR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J$5</c:f>
              <c:strCache>
                <c:ptCount val="1"/>
                <c:pt idx="0">
                  <c:v>aO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6:$N$10</c:f>
                <c:numCache>
                  <c:formatCode>General</c:formatCode>
                  <c:ptCount val="5"/>
                  <c:pt idx="0">
                    <c:v>4.0000000000000036E-2</c:v>
                  </c:pt>
                  <c:pt idx="1">
                    <c:v>3.9000000000000146E-2</c:v>
                  </c:pt>
                  <c:pt idx="2">
                    <c:v>3.7000000000000144E-2</c:v>
                  </c:pt>
                  <c:pt idx="3">
                    <c:v>3.7000000000000033E-2</c:v>
                  </c:pt>
                  <c:pt idx="4">
                    <c:v>3.1000000000000139E-2</c:v>
                  </c:pt>
                </c:numCache>
              </c:numRef>
            </c:plus>
            <c:minus>
              <c:numRef>
                <c:f>Sheet1!$L$6:$L$10</c:f>
                <c:numCache>
                  <c:formatCode>General</c:formatCode>
                  <c:ptCount val="5"/>
                  <c:pt idx="0">
                    <c:v>3.9000000000000146E-2</c:v>
                  </c:pt>
                  <c:pt idx="1">
                    <c:v>3.6999999999999922E-2</c:v>
                  </c:pt>
                  <c:pt idx="2">
                    <c:v>3.6999999999999922E-2</c:v>
                  </c:pt>
                  <c:pt idx="3">
                    <c:v>3.6000000000000032E-2</c:v>
                  </c:pt>
                  <c:pt idx="4">
                    <c:v>3.099999999999991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6:$A$10</c:f>
              <c:strCache>
                <c:ptCount val="5"/>
                <c:pt idx="0">
                  <c:v>2020 vs 2019</c:v>
                </c:pt>
                <c:pt idx="1">
                  <c:v>2020 vs 2018</c:v>
                </c:pt>
                <c:pt idx="2">
                  <c:v>2020 vs 2017</c:v>
                </c:pt>
                <c:pt idx="3">
                  <c:v>2020 vs 2016</c:v>
                </c:pt>
                <c:pt idx="4">
                  <c:v>2020 vs 2016-2019</c:v>
                </c:pt>
              </c:strCache>
            </c:strRef>
          </c:cat>
          <c:val>
            <c:numRef>
              <c:f>Sheet1!$J$6:$J$10</c:f>
              <c:numCache>
                <c:formatCode>General</c:formatCode>
                <c:ptCount val="5"/>
                <c:pt idx="0">
                  <c:v>1.06</c:v>
                </c:pt>
                <c:pt idx="1">
                  <c:v>1.0409999999999999</c:v>
                </c:pt>
                <c:pt idx="2">
                  <c:v>1.0129999999999999</c:v>
                </c:pt>
                <c:pt idx="3">
                  <c:v>0.999</c:v>
                </c:pt>
                <c:pt idx="4">
                  <c:v>1.026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4C2-4F2F-9F06-448F8936A7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01954320"/>
        <c:axId val="1601953904"/>
      </c:lineChart>
      <c:catAx>
        <c:axId val="1601954320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01953904"/>
        <c:crosses val="autoZero"/>
        <c:auto val="1"/>
        <c:lblAlgn val="ctr"/>
        <c:lblOffset val="100"/>
        <c:noMultiLvlLbl val="0"/>
      </c:catAx>
      <c:valAx>
        <c:axId val="160195390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0195432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</a:rPr>
              <a:t>APGAR&lt;7</a:t>
            </a:r>
            <a:r>
              <a:rPr lang="en-US" altLang="ja-JP" baseline="0">
                <a:solidFill>
                  <a:sysClr val="windowText" lastClr="000000"/>
                </a:solidFill>
              </a:rPr>
              <a:t> (1 min)</a:t>
            </a:r>
            <a:endParaRPr lang="en-US" altLang="ja-JP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A$5</c:f>
              <c:strCache>
                <c:ptCount val="1"/>
                <c:pt idx="0">
                  <c:v>aO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E$6:$AE$10</c:f>
                <c:numCache>
                  <c:formatCode>General</c:formatCode>
                  <c:ptCount val="5"/>
                  <c:pt idx="0">
                    <c:v>3.2000000000000028E-2</c:v>
                  </c:pt>
                  <c:pt idx="1">
                    <c:v>3.300000000000014E-2</c:v>
                  </c:pt>
                  <c:pt idx="2">
                    <c:v>3.400000000000003E-2</c:v>
                  </c:pt>
                  <c:pt idx="3">
                    <c:v>3.0999999999999917E-2</c:v>
                  </c:pt>
                  <c:pt idx="4">
                    <c:v>4.3000000000000149E-2</c:v>
                  </c:pt>
                </c:numCache>
              </c:numRef>
            </c:plus>
            <c:minus>
              <c:numRef>
                <c:f>Sheet1!$AC$6:$AC$10</c:f>
                <c:numCache>
                  <c:formatCode>General</c:formatCode>
                  <c:ptCount val="5"/>
                  <c:pt idx="0">
                    <c:v>3.2000000000000028E-2</c:v>
                  </c:pt>
                  <c:pt idx="1">
                    <c:v>3.2000000000000028E-2</c:v>
                  </c:pt>
                  <c:pt idx="2">
                    <c:v>3.2999999999999918E-2</c:v>
                  </c:pt>
                  <c:pt idx="3">
                    <c:v>3.1000000000000028E-2</c:v>
                  </c:pt>
                  <c:pt idx="4">
                    <c:v>4.099999999999992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6:$A$10</c:f>
              <c:strCache>
                <c:ptCount val="5"/>
                <c:pt idx="0">
                  <c:v>2020 vs 2019</c:v>
                </c:pt>
                <c:pt idx="1">
                  <c:v>2020 vs 2018</c:v>
                </c:pt>
                <c:pt idx="2">
                  <c:v>2020 vs 2017</c:v>
                </c:pt>
                <c:pt idx="3">
                  <c:v>2020 vs 2016</c:v>
                </c:pt>
                <c:pt idx="4">
                  <c:v>2020 vs 2016-2019</c:v>
                </c:pt>
              </c:strCache>
            </c:strRef>
          </c:cat>
          <c:val>
            <c:numRef>
              <c:f>Sheet1!$AA$6:$AA$10</c:f>
              <c:numCache>
                <c:formatCode>General</c:formatCode>
                <c:ptCount val="5"/>
                <c:pt idx="0">
                  <c:v>1.0329999999999999</c:v>
                </c:pt>
                <c:pt idx="1">
                  <c:v>1.0369999999999999</c:v>
                </c:pt>
                <c:pt idx="2">
                  <c:v>1.0469999999999999</c:v>
                </c:pt>
                <c:pt idx="3">
                  <c:v>1.006</c:v>
                </c:pt>
                <c:pt idx="4">
                  <c:v>1.042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361-424C-836E-A2C46F562A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11205920"/>
        <c:axId val="1611194272"/>
      </c:lineChart>
      <c:catAx>
        <c:axId val="1611205920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11194272"/>
        <c:crosses val="autoZero"/>
        <c:auto val="1"/>
        <c:lblAlgn val="ctr"/>
        <c:lblOffset val="100"/>
        <c:noMultiLvlLbl val="0"/>
      </c:catAx>
      <c:valAx>
        <c:axId val="161119427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1120592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</a:rPr>
              <a:t>APGAR&lt;7</a:t>
            </a:r>
            <a:r>
              <a:rPr lang="en-US" altLang="ja-JP" baseline="0">
                <a:solidFill>
                  <a:sysClr val="windowText" lastClr="000000"/>
                </a:solidFill>
              </a:rPr>
              <a:t> (5min)</a:t>
            </a:r>
            <a:endParaRPr lang="en-US" altLang="ja-JP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H$5</c:f>
              <c:strCache>
                <c:ptCount val="1"/>
                <c:pt idx="0">
                  <c:v>aO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AL$6:$AL$10</c:f>
                <c:numCache>
                  <c:formatCode>General</c:formatCode>
                  <c:ptCount val="5"/>
                  <c:pt idx="0">
                    <c:v>5.9000000000000163E-2</c:v>
                  </c:pt>
                  <c:pt idx="1">
                    <c:v>5.2999999999999936E-2</c:v>
                  </c:pt>
                  <c:pt idx="2">
                    <c:v>5.2999999999999936E-2</c:v>
                  </c:pt>
                  <c:pt idx="3">
                    <c:v>4.7000000000000042E-2</c:v>
                  </c:pt>
                  <c:pt idx="4">
                    <c:v>3.8999999999999924E-2</c:v>
                  </c:pt>
                </c:numCache>
              </c:numRef>
            </c:plus>
            <c:minus>
              <c:numRef>
                <c:f>Sheet1!$AJ$6:$AJ$10</c:f>
                <c:numCache>
                  <c:formatCode>General</c:formatCode>
                  <c:ptCount val="5"/>
                  <c:pt idx="0">
                    <c:v>5.5999999999999828E-2</c:v>
                  </c:pt>
                  <c:pt idx="1">
                    <c:v>5.1000000000000156E-2</c:v>
                  </c:pt>
                  <c:pt idx="2">
                    <c:v>5.1000000000000045E-2</c:v>
                  </c:pt>
                  <c:pt idx="3">
                    <c:v>4.4999999999999929E-2</c:v>
                  </c:pt>
                  <c:pt idx="4">
                    <c:v>3.700000000000014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6:$A$10</c:f>
              <c:strCache>
                <c:ptCount val="5"/>
                <c:pt idx="0">
                  <c:v>2020 vs 2019</c:v>
                </c:pt>
                <c:pt idx="1">
                  <c:v>2020 vs 2018</c:v>
                </c:pt>
                <c:pt idx="2">
                  <c:v>2020 vs 2017</c:v>
                </c:pt>
                <c:pt idx="3">
                  <c:v>2020 vs 2016</c:v>
                </c:pt>
                <c:pt idx="4">
                  <c:v>2020 vs 2016-2019</c:v>
                </c:pt>
              </c:strCache>
            </c:strRef>
          </c:cat>
          <c:val>
            <c:numRef>
              <c:f>Sheet1!$AH$6:$AH$10</c:f>
              <c:numCache>
                <c:formatCode>General</c:formatCode>
                <c:ptCount val="5"/>
                <c:pt idx="0">
                  <c:v>1.1339999999999999</c:v>
                </c:pt>
                <c:pt idx="1">
                  <c:v>1.052</c:v>
                </c:pt>
                <c:pt idx="2">
                  <c:v>1.046</c:v>
                </c:pt>
                <c:pt idx="3">
                  <c:v>0.95699999999999996</c:v>
                </c:pt>
                <c:pt idx="4">
                  <c:v>1.102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A48-4A10-9A9B-5B52D105D3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19658208"/>
        <c:axId val="1519670272"/>
      </c:lineChart>
      <c:catAx>
        <c:axId val="1519658208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19670272"/>
        <c:crosses val="autoZero"/>
        <c:auto val="1"/>
        <c:lblAlgn val="ctr"/>
        <c:lblOffset val="100"/>
        <c:noMultiLvlLbl val="0"/>
      </c:catAx>
      <c:valAx>
        <c:axId val="1519670272"/>
        <c:scaling>
          <c:orientation val="minMax"/>
          <c:min val="0.8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19658208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</a:rPr>
              <a:t>HD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C$5</c:f>
              <c:strCache>
                <c:ptCount val="1"/>
                <c:pt idx="0">
                  <c:v>aO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6:$G$10</c:f>
                <c:numCache>
                  <c:formatCode>General</c:formatCode>
                  <c:ptCount val="5"/>
                  <c:pt idx="0">
                    <c:v>8.2999999999999963E-2</c:v>
                  </c:pt>
                  <c:pt idx="1">
                    <c:v>8.1999999999999851E-2</c:v>
                  </c:pt>
                  <c:pt idx="2">
                    <c:v>8.6999999999999966E-2</c:v>
                  </c:pt>
                  <c:pt idx="3">
                    <c:v>8.9000000000000079E-2</c:v>
                  </c:pt>
                  <c:pt idx="4">
                    <c:v>7.0000000000000062E-2</c:v>
                  </c:pt>
                </c:numCache>
              </c:numRef>
            </c:plus>
            <c:minus>
              <c:numRef>
                <c:f>Sheet2!$E$6:$E$10</c:f>
                <c:numCache>
                  <c:formatCode>General</c:formatCode>
                  <c:ptCount val="5"/>
                  <c:pt idx="0">
                    <c:v>7.6000000000000068E-2</c:v>
                  </c:pt>
                  <c:pt idx="1">
                    <c:v>7.6000000000000068E-2</c:v>
                  </c:pt>
                  <c:pt idx="2">
                    <c:v>8.0999999999999961E-2</c:v>
                  </c:pt>
                  <c:pt idx="3">
                    <c:v>8.1999999999999962E-2</c:v>
                  </c:pt>
                  <c:pt idx="4">
                    <c:v>6.49999999999999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6:$A$10</c:f>
              <c:strCache>
                <c:ptCount val="5"/>
                <c:pt idx="0">
                  <c:v>2020 vs 2019</c:v>
                </c:pt>
                <c:pt idx="1">
                  <c:v>2020 vs 2018</c:v>
                </c:pt>
                <c:pt idx="2">
                  <c:v>2020 vs 2017</c:v>
                </c:pt>
                <c:pt idx="3">
                  <c:v>2020 vs 2016</c:v>
                </c:pt>
                <c:pt idx="4">
                  <c:v>2020 vs 2016-2019</c:v>
                </c:pt>
              </c:strCache>
            </c:strRef>
          </c:cat>
          <c:val>
            <c:numRef>
              <c:f>Sheet2!$C$6:$C$10</c:f>
              <c:numCache>
                <c:formatCode>General</c:formatCode>
                <c:ptCount val="5"/>
                <c:pt idx="0">
                  <c:v>0.93300000000000005</c:v>
                </c:pt>
                <c:pt idx="1">
                  <c:v>0.93500000000000005</c:v>
                </c:pt>
                <c:pt idx="2">
                  <c:v>0.97599999999999998</c:v>
                </c:pt>
                <c:pt idx="3">
                  <c:v>0.999</c:v>
                </c:pt>
                <c:pt idx="4">
                  <c:v>0.961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3F0-403D-B59B-B7CBB9DA74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19599440"/>
        <c:axId val="1719599856"/>
      </c:lineChart>
      <c:catAx>
        <c:axId val="1719599440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9599856"/>
        <c:crosses val="autoZero"/>
        <c:auto val="1"/>
        <c:lblAlgn val="ctr"/>
        <c:lblOffset val="100"/>
        <c:noMultiLvlLbl val="0"/>
      </c:catAx>
      <c:valAx>
        <c:axId val="1719599856"/>
        <c:scaling>
          <c:orientation val="minMax"/>
          <c:min val="0.70000000000000007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9599440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</a:rPr>
              <a:t>FGR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J$5</c:f>
              <c:strCache>
                <c:ptCount val="1"/>
                <c:pt idx="0">
                  <c:v>aO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N$6:$N$10</c:f>
                <c:numCache>
                  <c:formatCode>General</c:formatCode>
                  <c:ptCount val="5"/>
                  <c:pt idx="0">
                    <c:v>0.10899999999999999</c:v>
                  </c:pt>
                  <c:pt idx="1">
                    <c:v>0.10600000000000009</c:v>
                  </c:pt>
                  <c:pt idx="2">
                    <c:v>0.10200000000000009</c:v>
                  </c:pt>
                  <c:pt idx="3">
                    <c:v>0.10200000000000009</c:v>
                  </c:pt>
                  <c:pt idx="4">
                    <c:v>8.2999999999999963E-2</c:v>
                  </c:pt>
                </c:numCache>
              </c:numRef>
            </c:plus>
            <c:minus>
              <c:numRef>
                <c:f>Sheet2!$L$6:$L$10</c:f>
                <c:numCache>
                  <c:formatCode>General</c:formatCode>
                  <c:ptCount val="5"/>
                  <c:pt idx="0">
                    <c:v>0.10000000000000009</c:v>
                  </c:pt>
                  <c:pt idx="1">
                    <c:v>9.6000000000000085E-2</c:v>
                  </c:pt>
                  <c:pt idx="2">
                    <c:v>9.2999999999999972E-2</c:v>
                  </c:pt>
                  <c:pt idx="3">
                    <c:v>9.2999999999999972E-2</c:v>
                  </c:pt>
                  <c:pt idx="4">
                    <c:v>7.80000000000000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6:$A$10</c:f>
              <c:strCache>
                <c:ptCount val="5"/>
                <c:pt idx="0">
                  <c:v>2020 vs 2019</c:v>
                </c:pt>
                <c:pt idx="1">
                  <c:v>2020 vs 2018</c:v>
                </c:pt>
                <c:pt idx="2">
                  <c:v>2020 vs 2017</c:v>
                </c:pt>
                <c:pt idx="3">
                  <c:v>2020 vs 2016</c:v>
                </c:pt>
                <c:pt idx="4">
                  <c:v>2020 vs 2016-2019</c:v>
                </c:pt>
              </c:strCache>
            </c:strRef>
          </c:cat>
          <c:val>
            <c:numRef>
              <c:f>Sheet2!$J$6:$J$10</c:f>
              <c:numCache>
                <c:formatCode>General</c:formatCode>
                <c:ptCount val="5"/>
                <c:pt idx="0">
                  <c:v>1.149</c:v>
                </c:pt>
                <c:pt idx="1">
                  <c:v>1.125</c:v>
                </c:pt>
                <c:pt idx="2">
                  <c:v>1.093</c:v>
                </c:pt>
                <c:pt idx="3">
                  <c:v>1.101</c:v>
                </c:pt>
                <c:pt idx="4">
                  <c:v>1.112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31F-4CF3-83B3-3976D5DA2F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19575312"/>
        <c:axId val="1719576144"/>
      </c:lineChart>
      <c:catAx>
        <c:axId val="1719575312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9576144"/>
        <c:crosses val="autoZero"/>
        <c:auto val="1"/>
        <c:lblAlgn val="ctr"/>
        <c:lblOffset val="100"/>
        <c:noMultiLvlLbl val="0"/>
      </c:catAx>
      <c:valAx>
        <c:axId val="1719576144"/>
        <c:scaling>
          <c:orientation val="minMax"/>
          <c:min val="0.9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9575312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</a:rPr>
              <a:t>APGAR&lt;7</a:t>
            </a:r>
            <a:r>
              <a:rPr lang="en-US" altLang="ja-JP" baseline="0">
                <a:solidFill>
                  <a:sysClr val="windowText" lastClr="000000"/>
                </a:solidFill>
              </a:rPr>
              <a:t> (1min)</a:t>
            </a:r>
            <a:endParaRPr lang="en-US" altLang="ja-JP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AA$5</c:f>
              <c:strCache>
                <c:ptCount val="1"/>
                <c:pt idx="0">
                  <c:v>aO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AE$6:$AE$10</c:f>
                <c:numCache>
                  <c:formatCode>General</c:formatCode>
                  <c:ptCount val="5"/>
                  <c:pt idx="0">
                    <c:v>8.4000000000000075E-2</c:v>
                  </c:pt>
                  <c:pt idx="1">
                    <c:v>8.8000000000000078E-2</c:v>
                  </c:pt>
                  <c:pt idx="2">
                    <c:v>9.2999999999999972E-2</c:v>
                  </c:pt>
                  <c:pt idx="3">
                    <c:v>8.1000000000000072E-2</c:v>
                  </c:pt>
                  <c:pt idx="4">
                    <c:v>7.0000000000000062E-2</c:v>
                  </c:pt>
                </c:numCache>
              </c:numRef>
            </c:plus>
            <c:minus>
              <c:numRef>
                <c:f>Sheet2!$AC$6:$AC$10</c:f>
                <c:numCache>
                  <c:formatCode>General</c:formatCode>
                  <c:ptCount val="5"/>
                  <c:pt idx="0">
                    <c:v>7.7999999999999958E-2</c:v>
                  </c:pt>
                  <c:pt idx="1">
                    <c:v>8.099999999999985E-2</c:v>
                  </c:pt>
                  <c:pt idx="2">
                    <c:v>8.4000000000000075E-2</c:v>
                  </c:pt>
                  <c:pt idx="3">
                    <c:v>7.3999999999999955E-2</c:v>
                  </c:pt>
                  <c:pt idx="4">
                    <c:v>6.499999999999994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6:$A$10</c:f>
              <c:strCache>
                <c:ptCount val="5"/>
                <c:pt idx="0">
                  <c:v>2020 vs 2019</c:v>
                </c:pt>
                <c:pt idx="1">
                  <c:v>2020 vs 2018</c:v>
                </c:pt>
                <c:pt idx="2">
                  <c:v>2020 vs 2017</c:v>
                </c:pt>
                <c:pt idx="3">
                  <c:v>2020 vs 2016</c:v>
                </c:pt>
                <c:pt idx="4">
                  <c:v>2020 vs 2016-2019</c:v>
                </c:pt>
              </c:strCache>
            </c:strRef>
          </c:cat>
          <c:val>
            <c:numRef>
              <c:f>Sheet2!$AA$6:$AA$10</c:f>
              <c:numCache>
                <c:formatCode>General</c:formatCode>
                <c:ptCount val="5"/>
                <c:pt idx="0">
                  <c:v>0.97399999999999998</c:v>
                </c:pt>
                <c:pt idx="1">
                  <c:v>1.0169999999999999</c:v>
                </c:pt>
                <c:pt idx="2">
                  <c:v>1.048</c:v>
                </c:pt>
                <c:pt idx="3">
                  <c:v>0.94499999999999995</c:v>
                </c:pt>
                <c:pt idx="4">
                  <c:v>0.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FDD-45F0-AC1E-A7929C9D91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19590288"/>
        <c:axId val="1719592368"/>
      </c:lineChart>
      <c:catAx>
        <c:axId val="1719590288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9592368"/>
        <c:crosses val="autoZero"/>
        <c:auto val="1"/>
        <c:lblAlgn val="ctr"/>
        <c:lblOffset val="100"/>
        <c:noMultiLvlLbl val="0"/>
      </c:catAx>
      <c:valAx>
        <c:axId val="1719592368"/>
        <c:scaling>
          <c:orientation val="minMax"/>
          <c:min val="0.8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719590288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>
                <a:solidFill>
                  <a:sysClr val="windowText" lastClr="000000"/>
                </a:solidFill>
              </a:rPr>
              <a:t>APGAR&lt;7</a:t>
            </a:r>
            <a:r>
              <a:rPr lang="en-US" altLang="ja-JP" baseline="0">
                <a:solidFill>
                  <a:sysClr val="windowText" lastClr="000000"/>
                </a:solidFill>
              </a:rPr>
              <a:t> (5min)</a:t>
            </a:r>
            <a:endParaRPr lang="en-US" altLang="ja-JP">
              <a:solidFill>
                <a:sysClr val="windowText" lastClr="000000"/>
              </a:solidFill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2!$AH$5</c:f>
              <c:strCache>
                <c:ptCount val="1"/>
                <c:pt idx="0">
                  <c:v>aOR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AL$6:$AL$10</c:f>
                <c:numCache>
                  <c:formatCode>General</c:formatCode>
                  <c:ptCount val="5"/>
                  <c:pt idx="0">
                    <c:v>0.13600000000000001</c:v>
                  </c:pt>
                  <c:pt idx="1">
                    <c:v>0.15600000000000014</c:v>
                  </c:pt>
                  <c:pt idx="2">
                    <c:v>0.14000000000000001</c:v>
                  </c:pt>
                  <c:pt idx="3">
                    <c:v>0.11199999999999999</c:v>
                  </c:pt>
                  <c:pt idx="4">
                    <c:v>0.1070000000000001</c:v>
                  </c:pt>
                </c:numCache>
              </c:numRef>
            </c:plus>
            <c:minus>
              <c:numRef>
                <c:f>Sheet2!$AJ$6:$AJ$10</c:f>
                <c:numCache>
                  <c:formatCode>General</c:formatCode>
                  <c:ptCount val="5"/>
                  <c:pt idx="0">
                    <c:v>0.12</c:v>
                  </c:pt>
                  <c:pt idx="1">
                    <c:v>0.13500000000000001</c:v>
                  </c:pt>
                  <c:pt idx="2">
                    <c:v>0.122</c:v>
                  </c:pt>
                  <c:pt idx="3">
                    <c:v>9.7999999999999976E-2</c:v>
                  </c:pt>
                  <c:pt idx="4">
                    <c:v>9.599999999999997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A$6:$A$10</c:f>
              <c:strCache>
                <c:ptCount val="5"/>
                <c:pt idx="0">
                  <c:v>2020 vs 2019</c:v>
                </c:pt>
                <c:pt idx="1">
                  <c:v>2020 vs 2018</c:v>
                </c:pt>
                <c:pt idx="2">
                  <c:v>2020 vs 2017</c:v>
                </c:pt>
                <c:pt idx="3">
                  <c:v>2020 vs 2016</c:v>
                </c:pt>
                <c:pt idx="4">
                  <c:v>2020 vs 2016-2019</c:v>
                </c:pt>
              </c:strCache>
            </c:strRef>
          </c:cat>
          <c:val>
            <c:numRef>
              <c:f>Sheet2!$AH$6:$AH$10</c:f>
              <c:numCache>
                <c:formatCode>General</c:formatCode>
                <c:ptCount val="5"/>
                <c:pt idx="0">
                  <c:v>0.96299999999999997</c:v>
                </c:pt>
                <c:pt idx="1">
                  <c:v>1.085</c:v>
                </c:pt>
                <c:pt idx="2">
                  <c:v>0.98499999999999999</c:v>
                </c:pt>
                <c:pt idx="3">
                  <c:v>0.82799999999999996</c:v>
                </c:pt>
                <c:pt idx="4">
                  <c:v>0.9529999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ACB-4EBB-805C-EC77BB7B70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36053648"/>
        <c:axId val="1536059472"/>
      </c:lineChart>
      <c:catAx>
        <c:axId val="1536053648"/>
        <c:scaling>
          <c:orientation val="minMax"/>
        </c:scaling>
        <c:delete val="0"/>
        <c:axPos val="b"/>
        <c:numFmt formatCode="General" sourceLinked="1"/>
        <c:majorTickMark val="none"/>
        <c:minorTickMark val="cross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36059472"/>
        <c:crosses val="autoZero"/>
        <c:auto val="1"/>
        <c:lblAlgn val="ctr"/>
        <c:lblOffset val="100"/>
        <c:noMultiLvlLbl val="0"/>
      </c:catAx>
      <c:valAx>
        <c:axId val="1536059472"/>
        <c:scaling>
          <c:orientation val="minMax"/>
          <c:min val="0.60000000000000009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36053648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2228</cdr:x>
      <cdr:y>0.62442</cdr:y>
    </cdr:from>
    <cdr:to>
      <cdr:x>0.62548</cdr:x>
      <cdr:y>0.96308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61E07A35-AAA7-4DCD-9079-D6004964676A}"/>
            </a:ext>
          </a:extLst>
        </cdr:cNvPr>
        <cdr:cNvSpPr txBox="1"/>
      </cdr:nvSpPr>
      <cdr:spPr>
        <a:xfrm xmlns:a="http://schemas.openxmlformats.org/drawingml/2006/main">
          <a:off x="1900238" y="1685925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14076</cdr:x>
      <cdr:y>0.33678</cdr:y>
    </cdr:from>
    <cdr:to>
      <cdr:x>0.21273</cdr:x>
      <cdr:y>0.44097</cdr:y>
    </cdr:to>
    <cdr:sp macro="" textlink="">
      <cdr:nvSpPr>
        <cdr:cNvPr id="3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E361245E-B489-4A38-8248-7F2A419DC47B}"/>
            </a:ext>
          </a:extLst>
        </cdr:cNvPr>
        <cdr:cNvSpPr txBox="1"/>
      </cdr:nvSpPr>
      <cdr:spPr>
        <a:xfrm xmlns:a="http://schemas.openxmlformats.org/drawingml/2006/main">
          <a:off x="633413" y="90930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30798</cdr:x>
      <cdr:y>0.22036</cdr:y>
    </cdr:from>
    <cdr:to>
      <cdr:x>0.39053</cdr:x>
      <cdr:y>0.31044</cdr:y>
    </cdr:to>
    <cdr:sp macro="" textlink="">
      <cdr:nvSpPr>
        <cdr:cNvPr id="4" name="テキスト ボックス 3">
          <a:extLst xmlns:a="http://schemas.openxmlformats.org/drawingml/2006/main">
            <a:ext uri="{FF2B5EF4-FFF2-40B4-BE49-F238E27FC236}">
              <a16:creationId xmlns:a16="http://schemas.microsoft.com/office/drawing/2014/main" id="{30CFB9D3-D1F6-4A0E-B3C0-E44C7F51FB0A}"/>
            </a:ext>
          </a:extLst>
        </cdr:cNvPr>
        <cdr:cNvSpPr txBox="1"/>
      </cdr:nvSpPr>
      <cdr:spPr>
        <a:xfrm xmlns:a="http://schemas.openxmlformats.org/drawingml/2006/main">
          <a:off x="1385888" y="594975"/>
          <a:ext cx="371475" cy="243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altLang="ja-JP" sz="1100"/>
            <a:t>*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8331</cdr:x>
      <cdr:y>0.23401</cdr:y>
    </cdr:from>
    <cdr:to>
      <cdr:x>0.56586</cdr:x>
      <cdr:y>0.32409</cdr:y>
    </cdr:to>
    <cdr:sp macro="" textlink="">
      <cdr:nvSpPr>
        <cdr:cNvPr id="5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B5221561-FE18-41B9-926F-FA1DC1B615B0}"/>
            </a:ext>
          </a:extLst>
        </cdr:cNvPr>
        <cdr:cNvSpPr txBox="1"/>
      </cdr:nvSpPr>
      <cdr:spPr>
        <a:xfrm xmlns:a="http://schemas.openxmlformats.org/drawingml/2006/main">
          <a:off x="2174875" y="631825"/>
          <a:ext cx="371475" cy="243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6111</cdr:x>
      <cdr:y>0.15993</cdr:y>
    </cdr:from>
    <cdr:to>
      <cdr:x>0.74366</cdr:x>
      <cdr:y>0.25001</cdr:y>
    </cdr:to>
    <cdr:sp macro="" textlink="">
      <cdr:nvSpPr>
        <cdr:cNvPr id="7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B5221561-FE18-41B9-926F-FA1DC1B615B0}"/>
            </a:ext>
          </a:extLst>
        </cdr:cNvPr>
        <cdr:cNvSpPr txBox="1"/>
      </cdr:nvSpPr>
      <cdr:spPr>
        <a:xfrm xmlns:a="http://schemas.openxmlformats.org/drawingml/2006/main">
          <a:off x="2974975" y="431800"/>
          <a:ext cx="371475" cy="243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83467</cdr:x>
      <cdr:y>0.25518</cdr:y>
    </cdr:from>
    <cdr:to>
      <cdr:x>0.91722</cdr:x>
      <cdr:y>0.34526</cdr:y>
    </cdr:to>
    <cdr:sp macro="" textlink="">
      <cdr:nvSpPr>
        <cdr:cNvPr id="8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B5221561-FE18-41B9-926F-FA1DC1B615B0}"/>
            </a:ext>
          </a:extLst>
        </cdr:cNvPr>
        <cdr:cNvSpPr txBox="1"/>
      </cdr:nvSpPr>
      <cdr:spPr>
        <a:xfrm xmlns:a="http://schemas.openxmlformats.org/drawingml/2006/main">
          <a:off x="3756025" y="688975"/>
          <a:ext cx="371475" cy="243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**</a:t>
          </a:r>
          <a:endParaRPr lang="ja-JP" altLang="en-US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3805</cdr:x>
      <cdr:y>0.20719</cdr:y>
    </cdr:from>
    <cdr:to>
      <cdr:x>0.21378</cdr:x>
      <cdr:y>0.28928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B6DD9912-2302-4470-987D-59115CFE1ECE}"/>
            </a:ext>
          </a:extLst>
        </cdr:cNvPr>
        <cdr:cNvSpPr txBox="1"/>
      </cdr:nvSpPr>
      <cdr:spPr>
        <a:xfrm xmlns:a="http://schemas.openxmlformats.org/drawingml/2006/main">
          <a:off x="621225" y="559425"/>
          <a:ext cx="340800" cy="221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/>
            <a:t>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32432</cdr:x>
      <cdr:y>0.25306</cdr:y>
    </cdr:from>
    <cdr:to>
      <cdr:x>0.39793</cdr:x>
      <cdr:y>0.38453</cdr:y>
    </cdr:to>
    <cdr:sp macro="" textlink="">
      <cdr:nvSpPr>
        <cdr:cNvPr id="3" name="テキスト ボックス 2">
          <a:extLst xmlns:a="http://schemas.openxmlformats.org/drawingml/2006/main">
            <a:ext uri="{FF2B5EF4-FFF2-40B4-BE49-F238E27FC236}">
              <a16:creationId xmlns:a16="http://schemas.microsoft.com/office/drawing/2014/main" id="{AC259ED1-5EA3-496C-BC13-370C80B255B1}"/>
            </a:ext>
          </a:extLst>
        </cdr:cNvPr>
        <cdr:cNvSpPr txBox="1"/>
      </cdr:nvSpPr>
      <cdr:spPr>
        <a:xfrm xmlns:a="http://schemas.openxmlformats.org/drawingml/2006/main">
          <a:off x="1459425" y="683249"/>
          <a:ext cx="331275" cy="354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9177</cdr:x>
      <cdr:y>0.29751</cdr:y>
    </cdr:from>
    <cdr:to>
      <cdr:x>0.56374</cdr:x>
      <cdr:y>0.4017</cdr:y>
    </cdr:to>
    <cdr:sp macro="" textlink="">
      <cdr:nvSpPr>
        <cdr:cNvPr id="4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8DBF015A-8313-4E3A-A601-038F2F5AD4FA}"/>
            </a:ext>
          </a:extLst>
        </cdr:cNvPr>
        <cdr:cNvSpPr txBox="1"/>
      </cdr:nvSpPr>
      <cdr:spPr>
        <a:xfrm xmlns:a="http://schemas.openxmlformats.org/drawingml/2006/main">
          <a:off x="2212975" y="80327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6534</cdr:x>
      <cdr:y>0.33279</cdr:y>
    </cdr:from>
    <cdr:to>
      <cdr:x>0.73731</cdr:x>
      <cdr:y>0.43698</cdr:y>
    </cdr:to>
    <cdr:sp macro="" textlink="">
      <cdr:nvSpPr>
        <cdr:cNvPr id="5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8DBF015A-8313-4E3A-A601-038F2F5AD4FA}"/>
            </a:ext>
          </a:extLst>
        </cdr:cNvPr>
        <cdr:cNvSpPr txBox="1"/>
      </cdr:nvSpPr>
      <cdr:spPr>
        <a:xfrm xmlns:a="http://schemas.openxmlformats.org/drawingml/2006/main">
          <a:off x="2994025" y="89852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84314</cdr:x>
      <cdr:y>0.2834</cdr:y>
    </cdr:from>
    <cdr:to>
      <cdr:x>0.91511</cdr:x>
      <cdr:y>0.38759</cdr:y>
    </cdr:to>
    <cdr:sp macro="" textlink="">
      <cdr:nvSpPr>
        <cdr:cNvPr id="6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8DBF015A-8313-4E3A-A601-038F2F5AD4FA}"/>
            </a:ext>
          </a:extLst>
        </cdr:cNvPr>
        <cdr:cNvSpPr txBox="1"/>
      </cdr:nvSpPr>
      <cdr:spPr>
        <a:xfrm xmlns:a="http://schemas.openxmlformats.org/drawingml/2006/main">
          <a:off x="3794125" y="76517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4676</cdr:x>
      <cdr:y>0.20931</cdr:y>
    </cdr:from>
    <cdr:to>
      <cdr:x>0.22037</cdr:x>
      <cdr:y>0.34079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A0EA5346-3120-427E-BFF5-1CD17823718A}"/>
            </a:ext>
          </a:extLst>
        </cdr:cNvPr>
        <cdr:cNvSpPr txBox="1"/>
      </cdr:nvSpPr>
      <cdr:spPr>
        <a:xfrm xmlns:a="http://schemas.openxmlformats.org/drawingml/2006/main">
          <a:off x="660400" y="565150"/>
          <a:ext cx="331275" cy="354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32456</cdr:x>
      <cdr:y>0.18815</cdr:y>
    </cdr:from>
    <cdr:to>
      <cdr:x>0.39817</cdr:x>
      <cdr:y>0.31962</cdr:y>
    </cdr:to>
    <cdr:sp macro="" textlink="">
      <cdr:nvSpPr>
        <cdr:cNvPr id="3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A0EA5346-3120-427E-BFF5-1CD17823718A}"/>
            </a:ext>
          </a:extLst>
        </cdr:cNvPr>
        <cdr:cNvSpPr txBox="1"/>
      </cdr:nvSpPr>
      <cdr:spPr>
        <a:xfrm xmlns:a="http://schemas.openxmlformats.org/drawingml/2006/main">
          <a:off x="1460500" y="508000"/>
          <a:ext cx="331275" cy="354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8966</cdr:x>
      <cdr:y>0.17051</cdr:y>
    </cdr:from>
    <cdr:to>
      <cdr:x>0.56539</cdr:x>
      <cdr:y>0.25259</cdr:y>
    </cdr:to>
    <cdr:sp macro="" textlink="">
      <cdr:nvSpPr>
        <cdr:cNvPr id="5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C5F29CE8-DD36-45E4-A06C-C59AF8243D05}"/>
            </a:ext>
          </a:extLst>
        </cdr:cNvPr>
        <cdr:cNvSpPr txBox="1"/>
      </cdr:nvSpPr>
      <cdr:spPr>
        <a:xfrm xmlns:a="http://schemas.openxmlformats.org/drawingml/2006/main">
          <a:off x="2203450" y="460375"/>
          <a:ext cx="340800" cy="221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6746</cdr:x>
      <cdr:y>0.29045</cdr:y>
    </cdr:from>
    <cdr:to>
      <cdr:x>0.73942</cdr:x>
      <cdr:y>0.39465</cdr:y>
    </cdr:to>
    <cdr:sp macro="" textlink="">
      <cdr:nvSpPr>
        <cdr:cNvPr id="6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343BA98F-5609-4235-8A19-550E8322943B}"/>
            </a:ext>
          </a:extLst>
        </cdr:cNvPr>
        <cdr:cNvSpPr txBox="1"/>
      </cdr:nvSpPr>
      <cdr:spPr>
        <a:xfrm xmlns:a="http://schemas.openxmlformats.org/drawingml/2006/main">
          <a:off x="3003550" y="78422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85161</cdr:x>
      <cdr:y>0.1564</cdr:y>
    </cdr:from>
    <cdr:to>
      <cdr:x>0.92522</cdr:x>
      <cdr:y>0.28787</cdr:y>
    </cdr:to>
    <cdr:sp macro="" textlink="">
      <cdr:nvSpPr>
        <cdr:cNvPr id="7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A922C242-BC62-4940-9B58-52A23CD02C58}"/>
            </a:ext>
          </a:extLst>
        </cdr:cNvPr>
        <cdr:cNvSpPr txBox="1"/>
      </cdr:nvSpPr>
      <cdr:spPr>
        <a:xfrm xmlns:a="http://schemas.openxmlformats.org/drawingml/2006/main">
          <a:off x="3832225" y="422275"/>
          <a:ext cx="331275" cy="354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3194</cdr:x>
      <cdr:y>0.18109</cdr:y>
    </cdr:from>
    <cdr:to>
      <cdr:x>0.21449</cdr:x>
      <cdr:y>0.27118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CFBD5B5D-C0E5-496E-991E-7FC93F2A0C76}"/>
            </a:ext>
          </a:extLst>
        </cdr:cNvPr>
        <cdr:cNvSpPr txBox="1"/>
      </cdr:nvSpPr>
      <cdr:spPr>
        <a:xfrm xmlns:a="http://schemas.openxmlformats.org/drawingml/2006/main">
          <a:off x="593725" y="488950"/>
          <a:ext cx="371475" cy="243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32244</cdr:x>
      <cdr:y>0.30456</cdr:y>
    </cdr:from>
    <cdr:to>
      <cdr:x>0.39606</cdr:x>
      <cdr:y>0.43604</cdr:y>
    </cdr:to>
    <cdr:sp macro="" textlink="">
      <cdr:nvSpPr>
        <cdr:cNvPr id="3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C855789D-FAEF-4EB5-97F7-BBDD9649477C}"/>
            </a:ext>
          </a:extLst>
        </cdr:cNvPr>
        <cdr:cNvSpPr txBox="1"/>
      </cdr:nvSpPr>
      <cdr:spPr>
        <a:xfrm xmlns:a="http://schemas.openxmlformats.org/drawingml/2006/main">
          <a:off x="1450975" y="822325"/>
          <a:ext cx="331275" cy="354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6746</cdr:x>
      <cdr:y>0.44568</cdr:y>
    </cdr:from>
    <cdr:to>
      <cdr:x>0.73942</cdr:x>
      <cdr:y>0.54987</cdr:y>
    </cdr:to>
    <cdr:sp macro="" textlink="">
      <cdr:nvSpPr>
        <cdr:cNvPr id="4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B1EAEB59-A84E-48E6-A75E-7873896956D8}"/>
            </a:ext>
          </a:extLst>
        </cdr:cNvPr>
        <cdr:cNvSpPr txBox="1"/>
      </cdr:nvSpPr>
      <cdr:spPr>
        <a:xfrm xmlns:a="http://schemas.openxmlformats.org/drawingml/2006/main">
          <a:off x="3003550" y="120332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8966</cdr:x>
      <cdr:y>0.30104</cdr:y>
    </cdr:from>
    <cdr:to>
      <cdr:x>0.56162</cdr:x>
      <cdr:y>0.40523</cdr:y>
    </cdr:to>
    <cdr:sp macro="" textlink="">
      <cdr:nvSpPr>
        <cdr:cNvPr id="5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B1EAEB59-A84E-48E6-A75E-7873896956D8}"/>
            </a:ext>
          </a:extLst>
        </cdr:cNvPr>
        <cdr:cNvSpPr txBox="1"/>
      </cdr:nvSpPr>
      <cdr:spPr>
        <a:xfrm xmlns:a="http://schemas.openxmlformats.org/drawingml/2006/main">
          <a:off x="2203450" y="81280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85372</cdr:x>
      <cdr:y>0.25518</cdr:y>
    </cdr:from>
    <cdr:to>
      <cdr:x>0.92734</cdr:x>
      <cdr:y>0.38665</cdr:y>
    </cdr:to>
    <cdr:sp macro="" textlink="">
      <cdr:nvSpPr>
        <cdr:cNvPr id="6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54F3972-BE5E-4257-AF99-CF90FE01C4AB}"/>
            </a:ext>
          </a:extLst>
        </cdr:cNvPr>
        <cdr:cNvSpPr txBox="1"/>
      </cdr:nvSpPr>
      <cdr:spPr>
        <a:xfrm xmlns:a="http://schemas.openxmlformats.org/drawingml/2006/main">
          <a:off x="3841750" y="688975"/>
          <a:ext cx="331275" cy="354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31821</cdr:x>
      <cdr:y>0.26929</cdr:y>
    </cdr:from>
    <cdr:to>
      <cdr:x>0.39017</cdr:x>
      <cdr:y>0.37348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1431925" y="72707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 dirty="0"/>
            <a:t>ns</a:t>
          </a:r>
          <a:endParaRPr lang="ja-JP" altLang="en-US" sz="1100" dirty="0"/>
        </a:p>
      </cdr:txBody>
    </cdr:sp>
  </cdr:relSizeAnchor>
  <cdr:relSizeAnchor xmlns:cdr="http://schemas.openxmlformats.org/drawingml/2006/chartDrawing">
    <cdr:from>
      <cdr:x>0.48966</cdr:x>
      <cdr:y>0.20931</cdr:y>
    </cdr:from>
    <cdr:to>
      <cdr:x>0.56162</cdr:x>
      <cdr:y>0.31351</cdr:y>
    </cdr:to>
    <cdr:sp macro="" textlink="">
      <cdr:nvSpPr>
        <cdr:cNvPr id="3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2203450" y="56515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6534</cdr:x>
      <cdr:y>0.17051</cdr:y>
    </cdr:from>
    <cdr:to>
      <cdr:x>0.73731</cdr:x>
      <cdr:y>0.2747</cdr:y>
    </cdr:to>
    <cdr:sp macro="" textlink="">
      <cdr:nvSpPr>
        <cdr:cNvPr id="4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2994025" y="46037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84314</cdr:x>
      <cdr:y>0.25518</cdr:y>
    </cdr:from>
    <cdr:to>
      <cdr:x>0.91511</cdr:x>
      <cdr:y>0.35937</cdr:y>
    </cdr:to>
    <cdr:sp macro="" textlink="">
      <cdr:nvSpPr>
        <cdr:cNvPr id="5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3794125" y="68897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13617</cdr:x>
      <cdr:y>0.17051</cdr:y>
    </cdr:from>
    <cdr:to>
      <cdr:x>0.21191</cdr:x>
      <cdr:y>0.25259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44CB29B8-9813-4DE7-B239-AF4CA340D150}"/>
            </a:ext>
          </a:extLst>
        </cdr:cNvPr>
        <cdr:cNvSpPr txBox="1"/>
      </cdr:nvSpPr>
      <cdr:spPr>
        <a:xfrm xmlns:a="http://schemas.openxmlformats.org/drawingml/2006/main">
          <a:off x="612775" y="460375"/>
          <a:ext cx="340800" cy="221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32456</cdr:x>
      <cdr:y>0.20579</cdr:y>
    </cdr:from>
    <cdr:to>
      <cdr:x>0.39817</cdr:x>
      <cdr:y>0.33726</cdr:y>
    </cdr:to>
    <cdr:sp macro="" textlink="">
      <cdr:nvSpPr>
        <cdr:cNvPr id="3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A6797D6-8005-4271-8435-30D4C8459798}"/>
            </a:ext>
          </a:extLst>
        </cdr:cNvPr>
        <cdr:cNvSpPr txBox="1"/>
      </cdr:nvSpPr>
      <cdr:spPr>
        <a:xfrm xmlns:a="http://schemas.openxmlformats.org/drawingml/2006/main">
          <a:off x="1460500" y="555625"/>
          <a:ext cx="331275" cy="354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8966</cdr:x>
      <cdr:y>0.25165</cdr:y>
    </cdr:from>
    <cdr:to>
      <cdr:x>0.56162</cdr:x>
      <cdr:y>0.35584</cdr:y>
    </cdr:to>
    <cdr:sp macro="" textlink="">
      <cdr:nvSpPr>
        <cdr:cNvPr id="4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1AA70D2E-31AF-4823-912C-BC1523ECC71B}"/>
            </a:ext>
          </a:extLst>
        </cdr:cNvPr>
        <cdr:cNvSpPr txBox="1"/>
      </cdr:nvSpPr>
      <cdr:spPr>
        <a:xfrm xmlns:a="http://schemas.openxmlformats.org/drawingml/2006/main">
          <a:off x="2203450" y="67945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7592</cdr:x>
      <cdr:y>0.25165</cdr:y>
    </cdr:from>
    <cdr:to>
      <cdr:x>0.74954</cdr:x>
      <cdr:y>0.38312</cdr:y>
    </cdr:to>
    <cdr:sp macro="" textlink="">
      <cdr:nvSpPr>
        <cdr:cNvPr id="5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486B18D4-2EEE-487F-BB29-2CD22E185261}"/>
            </a:ext>
          </a:extLst>
        </cdr:cNvPr>
        <cdr:cNvSpPr txBox="1"/>
      </cdr:nvSpPr>
      <cdr:spPr>
        <a:xfrm xmlns:a="http://schemas.openxmlformats.org/drawingml/2006/main">
          <a:off x="3041650" y="679450"/>
          <a:ext cx="331275" cy="3549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84314</cdr:x>
      <cdr:y>0.26929</cdr:y>
    </cdr:from>
    <cdr:to>
      <cdr:x>0.91887</cdr:x>
      <cdr:y>0.35137</cdr:y>
    </cdr:to>
    <cdr:sp macro="" textlink="">
      <cdr:nvSpPr>
        <cdr:cNvPr id="6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8E70CE9F-FD73-43CE-8D5E-7D91D414D3F9}"/>
            </a:ext>
          </a:extLst>
        </cdr:cNvPr>
        <cdr:cNvSpPr txBox="1"/>
      </cdr:nvSpPr>
      <cdr:spPr>
        <a:xfrm xmlns:a="http://schemas.openxmlformats.org/drawingml/2006/main">
          <a:off x="3794125" y="727075"/>
          <a:ext cx="340800" cy="221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*</a:t>
          </a:r>
          <a:endParaRPr lang="ja-JP" altLang="en-US" sz="110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13617</cdr:x>
      <cdr:y>0.30809</cdr:y>
    </cdr:from>
    <cdr:to>
      <cdr:x>0.20814</cdr:x>
      <cdr:y>0.41229</cdr:y>
    </cdr:to>
    <cdr:sp macro="" textlink="">
      <cdr:nvSpPr>
        <cdr:cNvPr id="2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612775" y="83185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31397</cdr:x>
      <cdr:y>0.23754</cdr:y>
    </cdr:from>
    <cdr:to>
      <cdr:x>0.38594</cdr:x>
      <cdr:y>0.34173</cdr:y>
    </cdr:to>
    <cdr:sp macro="" textlink="">
      <cdr:nvSpPr>
        <cdr:cNvPr id="3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1412875" y="64135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9177</cdr:x>
      <cdr:y>0.18109</cdr:y>
    </cdr:from>
    <cdr:to>
      <cdr:x>0.56374</cdr:x>
      <cdr:y>0.28529</cdr:y>
    </cdr:to>
    <cdr:sp macro="" textlink="">
      <cdr:nvSpPr>
        <cdr:cNvPr id="4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2212975" y="48895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6534</cdr:x>
      <cdr:y>0.37159</cdr:y>
    </cdr:from>
    <cdr:to>
      <cdr:x>0.73731</cdr:x>
      <cdr:y>0.47579</cdr:y>
    </cdr:to>
    <cdr:sp macro="" textlink="">
      <cdr:nvSpPr>
        <cdr:cNvPr id="5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2994025" y="100330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84314</cdr:x>
      <cdr:y>0.30456</cdr:y>
    </cdr:from>
    <cdr:to>
      <cdr:x>0.91511</cdr:x>
      <cdr:y>0.40876</cdr:y>
    </cdr:to>
    <cdr:sp macro="" textlink="">
      <cdr:nvSpPr>
        <cdr:cNvPr id="6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3794125" y="82232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12771</cdr:x>
      <cdr:y>0.26576</cdr:y>
    </cdr:from>
    <cdr:to>
      <cdr:x>0.19967</cdr:x>
      <cdr:y>0.36995</cdr:y>
    </cdr:to>
    <cdr:sp macro="" textlink="">
      <cdr:nvSpPr>
        <cdr:cNvPr id="3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574675" y="71755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30762</cdr:x>
      <cdr:y>0.14581</cdr:y>
    </cdr:from>
    <cdr:to>
      <cdr:x>0.37959</cdr:x>
      <cdr:y>0.25001</cdr:y>
    </cdr:to>
    <cdr:sp macro="" textlink="">
      <cdr:nvSpPr>
        <cdr:cNvPr id="4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1384300" y="393700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48542</cdr:x>
      <cdr:y>0.24812</cdr:y>
    </cdr:from>
    <cdr:to>
      <cdr:x>0.55739</cdr:x>
      <cdr:y>0.35231</cdr:y>
    </cdr:to>
    <cdr:sp macro="" textlink="">
      <cdr:nvSpPr>
        <cdr:cNvPr id="5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0C89D841-5572-47CE-9B3E-2EBABEA48FE7}"/>
            </a:ext>
          </a:extLst>
        </cdr:cNvPr>
        <cdr:cNvSpPr txBox="1"/>
      </cdr:nvSpPr>
      <cdr:spPr>
        <a:xfrm xmlns:a="http://schemas.openxmlformats.org/drawingml/2006/main">
          <a:off x="2184400" y="66992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65899</cdr:x>
      <cdr:y>0.43509</cdr:y>
    </cdr:from>
    <cdr:to>
      <cdr:x>0.73472</cdr:x>
      <cdr:y>0.51718</cdr:y>
    </cdr:to>
    <cdr:sp macro="" textlink="">
      <cdr:nvSpPr>
        <cdr:cNvPr id="6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F7DF7796-DEBC-4866-A898-1985518C3155}"/>
            </a:ext>
          </a:extLst>
        </cdr:cNvPr>
        <cdr:cNvSpPr txBox="1"/>
      </cdr:nvSpPr>
      <cdr:spPr>
        <a:xfrm xmlns:a="http://schemas.openxmlformats.org/drawingml/2006/main">
          <a:off x="2965450" y="1174750"/>
          <a:ext cx="340800" cy="221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**</a:t>
          </a:r>
          <a:endParaRPr lang="ja-JP" altLang="en-US" sz="1100"/>
        </a:p>
      </cdr:txBody>
    </cdr:sp>
  </cdr:relSizeAnchor>
  <cdr:relSizeAnchor xmlns:cdr="http://schemas.openxmlformats.org/drawingml/2006/chartDrawing">
    <cdr:from>
      <cdr:x>0.84314</cdr:x>
      <cdr:y>0.31162</cdr:y>
    </cdr:from>
    <cdr:to>
      <cdr:x>0.91511</cdr:x>
      <cdr:y>0.41581</cdr:y>
    </cdr:to>
    <cdr:sp macro="" textlink="">
      <cdr:nvSpPr>
        <cdr:cNvPr id="7" name="テキスト ボックス 1">
          <a:extLst xmlns:a="http://schemas.openxmlformats.org/drawingml/2006/main">
            <a:ext uri="{FF2B5EF4-FFF2-40B4-BE49-F238E27FC236}">
              <a16:creationId xmlns:a16="http://schemas.microsoft.com/office/drawing/2014/main" id="{A4D7CC05-3004-4F0C-939D-15E8C5BE09EB}"/>
            </a:ext>
          </a:extLst>
        </cdr:cNvPr>
        <cdr:cNvSpPr txBox="1"/>
      </cdr:nvSpPr>
      <cdr:spPr>
        <a:xfrm xmlns:a="http://schemas.openxmlformats.org/drawingml/2006/main">
          <a:off x="3794125" y="841375"/>
          <a:ext cx="323850" cy="281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ja-JP" sz="1100"/>
            <a:t>ns</a:t>
          </a:r>
          <a:endParaRPr lang="ja-JP" altLang="en-US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7A9660-F5B9-4E88-A5FA-F9CADD4C9F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947C5F2-24F0-4677-802B-81280ADA8F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E39CA1-B26C-4502-AC11-8C184E2EE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0FF7E7-BFF1-497C-8523-54BF4F5E00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923C0D-E7A2-4CC8-81C2-2698C0311D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66466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4A3A74-2063-480B-BCED-670FEA9897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FB21E2C-FE72-4A6C-A101-937210AEF3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A7C38C-8ADF-4B3F-B53F-F7A5D58CF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B991B87-FC8C-4C58-8722-CA0F31C33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DC64D9D-CD63-4BD7-980D-AB5B5FD22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94952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3872A80-5257-4A94-B612-C50AD24177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ACBCDA7-468D-4E45-9797-923948BF85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B5A8BD-7250-40F7-805B-7962500ED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9D8506-E2AB-4E0F-BD08-6CAF21F4B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04A7FA-8282-4C15-9C13-CB7C99336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72203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0D9813-36A4-497D-89D2-B2F63AF62C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A67315-B462-40A0-AA73-19C4551048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CAC62B-82BB-4BE0-BA01-81B5347A6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5D4FBE8-F538-4240-9505-FAB4B89E6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5449FE-F16A-4788-ACFB-E7A815290D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14840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BAFA9C2-3B81-47DE-B4BB-2B1E5A930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EF368F-A7B2-4C3D-B4A1-7FB40DA486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4E3C56-A507-46C5-B96F-12419F74D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E17C44-C84D-491F-A2C6-D43A62767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83E49A0-D25A-46C6-9D2C-812B89231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90036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0C6A4E-BEA3-457C-A36C-CBF8E2D826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B5CFA06-6782-4332-9B6A-C1E9F6F627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71CC1D3-95A2-48CC-8E41-D02DA947F0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CD771AC-CFCC-4D60-8EAD-8E5737F12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A1F74B7-9C4C-4F55-821A-236AF4194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A1EB050-CDDC-43E4-86F7-F732BD526C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43429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431BED-FDEB-4E7E-B023-ED6D1938F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5A2B4CE-AD32-43A0-BF92-4544C44A4D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4DED039-FEB9-47DE-85DC-4267796277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DDCA516-0597-44C3-AB97-E0A3A93FE3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11DD58D-B30D-4304-9500-0F13663357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306835F-0F4E-4AB3-823E-042CCD73B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3028929-A4E1-4DF6-8D2A-CFBAA4C91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32DE89E-3EC5-44D5-A1CF-107D8E2FF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70490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7A59B2-20F8-4F1E-A6AE-A1F52E9BEB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830F4BD-D583-4B05-90E8-35F0F1276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A71094E-E968-4B40-9ABB-DBF14505F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FAFF9DB-E950-47B5-B6BE-FAE5FE82D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51398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2257E7C-715B-4118-885E-8DFA78E66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18E2DCC-51D0-47BD-85DC-CA9510F9A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820F94C-7EA2-4AC6-A158-929BB2C6A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08218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0142D7-5288-4336-B6D1-0565E3FB8B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041CBA-046E-4E11-A709-3A7D2BCB47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AAD498E-96DD-45B4-8A0C-20B65D19AA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0D924CB-EAA0-470E-934E-AE24954CF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F9EB6C4-D693-4B37-814D-DBE785E1D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5C1828-8D95-4F2B-A2C7-CE2419DE1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3294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1355D5-CB37-4A41-8053-0E3D6E79B0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4E062FA-84AC-4B81-9216-333D1E9381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644D317-CB1C-4CB8-A751-4B714F81B2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353A8C2-C8B9-4F90-89B7-B1FEEB3E8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5ECBCF4-8717-48C9-A1D4-63040A7F67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3BC3413-79DB-4F4E-873A-AD0A9D350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19041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AFB4FF9-7567-4440-B37B-078A7F6EE3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9B75344-7BB2-4567-9128-73F3C27E5B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E81E20-404B-4677-A91A-7E628DF783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0586F1-C2D8-49A0-AA96-12C43B98FBBB}" type="datetimeFigureOut">
              <a:rPr kumimoji="1" lang="ja-JP" altLang="en-US" smtClean="0"/>
              <a:t>2023/11/27</a:t>
            </a:fld>
            <a:endParaRPr kumimoji="1" lang="ja-JP" altLang="en-US" dirty="0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4C2570-C4D9-4255-9509-8887D37C2D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FDB914-23E9-4FB4-8285-5F673288D7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D0C9D-D8E4-45DF-986E-3FDEC9DEA2A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723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4529896-EEF8-47A7-AD6E-F50943B468FE}"/>
              </a:ext>
            </a:extLst>
          </p:cNvPr>
          <p:cNvSpPr txBox="1"/>
          <p:nvPr/>
        </p:nvSpPr>
        <p:spPr>
          <a:xfrm>
            <a:off x="1897235" y="349155"/>
            <a:ext cx="80634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S1. Comparison of main outcomes between each year and 2020 in singleton pregnancy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98502FF-87EE-47AA-B0EB-440426534C8A}"/>
              </a:ext>
            </a:extLst>
          </p:cNvPr>
          <p:cNvSpPr txBox="1"/>
          <p:nvPr/>
        </p:nvSpPr>
        <p:spPr>
          <a:xfrm>
            <a:off x="1609357" y="5816633"/>
            <a:ext cx="91764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:</a:t>
            </a:r>
            <a:r>
              <a: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5,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: p&lt;0.01,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: p&lt;0.0001, ns.: not significant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s 95% confidence interval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P was adjusted for age at delivery, delivery location, pre-pregnancy BMI, fertility treatment, and FGR.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GR was adjusted for age at delivery, delivery location, pre-pregnancy BMI, fertility treatment, and HDP.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GAR&lt;7 (1 min and 5 min) were adjusted for age at delivery, delivery location, pre-pregnancy BMI, fertility treatment, mode of delivery, HDP, FGR, gestational age at delivery, and birth weight.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40DEEF11-482B-4B82-9421-6FAA6ADDE19C}"/>
              </a:ext>
            </a:extLst>
          </p:cNvPr>
          <p:cNvGrpSpPr/>
          <p:nvPr/>
        </p:nvGrpSpPr>
        <p:grpSpPr>
          <a:xfrm>
            <a:off x="1320626" y="682333"/>
            <a:ext cx="9214011" cy="5189884"/>
            <a:chOff x="931157" y="851674"/>
            <a:chExt cx="9214011" cy="5189884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C3F29FC4-DC34-4EC3-9510-1719299803FF}"/>
                </a:ext>
              </a:extLst>
            </p:cNvPr>
            <p:cNvSpPr txBox="1"/>
            <p:nvPr/>
          </p:nvSpPr>
          <p:spPr>
            <a:xfrm rot="10800000">
              <a:off x="931157" y="1752678"/>
              <a:ext cx="353943" cy="73674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ds ratios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077029AC-DF71-43F6-AF33-6D1C94CE8DC5}"/>
                </a:ext>
              </a:extLst>
            </p:cNvPr>
            <p:cNvSpPr txBox="1"/>
            <p:nvPr/>
          </p:nvSpPr>
          <p:spPr>
            <a:xfrm rot="10800000">
              <a:off x="933863" y="4317618"/>
              <a:ext cx="353943" cy="73674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ds ratios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1" name="グラフ 10">
              <a:extLst>
                <a:ext uri="{FF2B5EF4-FFF2-40B4-BE49-F238E27FC236}">
                  <a16:creationId xmlns:a16="http://schemas.microsoft.com/office/drawing/2014/main" id="{53F31A62-4424-4EC7-89CA-73EB71693D5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06157152"/>
                </p:ext>
              </p:extLst>
            </p:nvPr>
          </p:nvGraphicFramePr>
          <p:xfrm>
            <a:off x="1145168" y="851674"/>
            <a:ext cx="450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3" name="グラフ 12">
              <a:extLst>
                <a:ext uri="{FF2B5EF4-FFF2-40B4-BE49-F238E27FC236}">
                  <a16:creationId xmlns:a16="http://schemas.microsoft.com/office/drawing/2014/main" id="{9DB49468-2D76-4EDF-8F2F-C065CD8B71F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04456883"/>
                </p:ext>
              </p:extLst>
            </p:nvPr>
          </p:nvGraphicFramePr>
          <p:xfrm>
            <a:off x="5629596" y="851674"/>
            <a:ext cx="450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4" name="グラフ 13">
              <a:extLst>
                <a:ext uri="{FF2B5EF4-FFF2-40B4-BE49-F238E27FC236}">
                  <a16:creationId xmlns:a16="http://schemas.microsoft.com/office/drawing/2014/main" id="{517178D0-A306-4F2A-AB3A-15731A204BC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13806164"/>
                </p:ext>
              </p:extLst>
            </p:nvPr>
          </p:nvGraphicFramePr>
          <p:xfrm>
            <a:off x="1145168" y="3341558"/>
            <a:ext cx="450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5" name="グラフ 14">
              <a:extLst>
                <a:ext uri="{FF2B5EF4-FFF2-40B4-BE49-F238E27FC236}">
                  <a16:creationId xmlns:a16="http://schemas.microsoft.com/office/drawing/2014/main" id="{2B16091A-16D4-4CBB-B711-3D07A737C4F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96456609"/>
                </p:ext>
              </p:extLst>
            </p:nvPr>
          </p:nvGraphicFramePr>
          <p:xfrm>
            <a:off x="5645168" y="3341558"/>
            <a:ext cx="450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3553522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40ADA68-DCE4-471F-A098-2F7A7E565D34}"/>
              </a:ext>
            </a:extLst>
          </p:cNvPr>
          <p:cNvSpPr txBox="1"/>
          <p:nvPr/>
        </p:nvSpPr>
        <p:spPr>
          <a:xfrm>
            <a:off x="2012450" y="339141"/>
            <a:ext cx="8021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ure S2. Comparison of main outcomes between each year and 2020 in multiple pregnancy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A3E6262-B812-422A-A640-4F0484554D95}"/>
              </a:ext>
            </a:extLst>
          </p:cNvPr>
          <p:cNvSpPr txBox="1"/>
          <p:nvPr/>
        </p:nvSpPr>
        <p:spPr>
          <a:xfrm>
            <a:off x="1594878" y="5829332"/>
            <a:ext cx="917646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:</a:t>
            </a:r>
            <a:r>
              <a:rPr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5,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: p&lt;0.01, 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: p&lt;0.0001, ns.: not significant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ror bars shows 95% confidence interval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P was adjusted for age at delivery, delivery location, pre-pregnancy BMI, fertility treatment, and FGR.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GR was adjusted for age at delivery, delivery location, pre-pregnancy BMI, fertility treatment, and HDP.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GAR&lt;7 (1 min and 5 min) were adjusted for age at delivery, delivery location, pre-pregnancy BMI, fertility treatment, mode of delivery, HDP, FGR, gestational age at delivery, and birth weight.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4C403932-39C9-4AD5-A95D-2B56DF4B39A1}"/>
              </a:ext>
            </a:extLst>
          </p:cNvPr>
          <p:cNvGrpSpPr/>
          <p:nvPr/>
        </p:nvGrpSpPr>
        <p:grpSpPr>
          <a:xfrm>
            <a:off x="1391077" y="693256"/>
            <a:ext cx="9303340" cy="5209409"/>
            <a:chOff x="1204806" y="879530"/>
            <a:chExt cx="9303340" cy="5209409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5CFD547D-0080-49D2-9D60-DD5B2B34D7CC}"/>
                </a:ext>
              </a:extLst>
            </p:cNvPr>
            <p:cNvSpPr txBox="1"/>
            <p:nvPr/>
          </p:nvSpPr>
          <p:spPr>
            <a:xfrm rot="10800000">
              <a:off x="1204807" y="1685597"/>
              <a:ext cx="353943" cy="73674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ds ratios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B545D783-CBF7-4A1C-81E3-4237D27809F5}"/>
                </a:ext>
              </a:extLst>
            </p:cNvPr>
            <p:cNvSpPr txBox="1"/>
            <p:nvPr/>
          </p:nvSpPr>
          <p:spPr>
            <a:xfrm rot="10800000">
              <a:off x="1204806" y="4273051"/>
              <a:ext cx="353943" cy="73674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kumimoji="1" lang="en-US" altLang="ja-JP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dds ratios</a:t>
              </a:r>
              <a:endParaRPr kumimoji="1"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3" name="グラフ 12">
              <a:extLst>
                <a:ext uri="{FF2B5EF4-FFF2-40B4-BE49-F238E27FC236}">
                  <a16:creationId xmlns:a16="http://schemas.microsoft.com/office/drawing/2014/main" id="{4B7EEE00-920D-4102-8302-459A964037E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04173269"/>
                </p:ext>
              </p:extLst>
            </p:nvPr>
          </p:nvGraphicFramePr>
          <p:xfrm>
            <a:off x="1431413" y="879530"/>
            <a:ext cx="450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5" name="グラフ 14">
              <a:extLst>
                <a:ext uri="{FF2B5EF4-FFF2-40B4-BE49-F238E27FC236}">
                  <a16:creationId xmlns:a16="http://schemas.microsoft.com/office/drawing/2014/main" id="{4794C5D4-76F2-47F0-8864-90EF3B77078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23972514"/>
                </p:ext>
              </p:extLst>
            </p:nvPr>
          </p:nvGraphicFramePr>
          <p:xfrm>
            <a:off x="6008146" y="879530"/>
            <a:ext cx="450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9" name="グラフ 18">
              <a:extLst>
                <a:ext uri="{FF2B5EF4-FFF2-40B4-BE49-F238E27FC236}">
                  <a16:creationId xmlns:a16="http://schemas.microsoft.com/office/drawing/2014/main" id="{E68F6663-7C4B-4F8D-BFE9-DFF4D0BD742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75710364"/>
                </p:ext>
              </p:extLst>
            </p:nvPr>
          </p:nvGraphicFramePr>
          <p:xfrm>
            <a:off x="1431218" y="3388939"/>
            <a:ext cx="450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0" name="グラフ 19">
              <a:extLst>
                <a:ext uri="{FF2B5EF4-FFF2-40B4-BE49-F238E27FC236}">
                  <a16:creationId xmlns:a16="http://schemas.microsoft.com/office/drawing/2014/main" id="{D33F0855-B464-454F-80A8-D8049C3C92A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95394014"/>
                </p:ext>
              </p:extLst>
            </p:nvPr>
          </p:nvGraphicFramePr>
          <p:xfrm>
            <a:off x="6008146" y="3388939"/>
            <a:ext cx="4500000" cy="27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21" name="テキスト ボックス 1">
              <a:extLst>
                <a:ext uri="{FF2B5EF4-FFF2-40B4-BE49-F238E27FC236}">
                  <a16:creationId xmlns:a16="http://schemas.microsoft.com/office/drawing/2014/main" id="{1A151AB2-DE76-4E50-BCD6-40F10D9677C5}"/>
                </a:ext>
              </a:extLst>
            </p:cNvPr>
            <p:cNvSpPr txBox="1"/>
            <p:nvPr/>
          </p:nvSpPr>
          <p:spPr>
            <a:xfrm>
              <a:off x="2047890" y="1630614"/>
              <a:ext cx="323820" cy="281313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100" dirty="0">
                  <a:latin typeface="Calibri" panose="020F050202020403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ns</a:t>
              </a:r>
              <a:endParaRPr lang="ja-JP" altLang="en-US" sz="11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17360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02</TotalTime>
  <Words>327</Words>
  <Application>Microsoft Office PowerPoint</Application>
  <PresentationFormat>ワイド画面</PresentationFormat>
  <Paragraphs>6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阿部　美子</dc:creator>
  <cp:lastModifiedBy>阿部　美子</cp:lastModifiedBy>
  <cp:revision>15</cp:revision>
  <dcterms:created xsi:type="dcterms:W3CDTF">2023-10-30T10:02:38Z</dcterms:created>
  <dcterms:modified xsi:type="dcterms:W3CDTF">2023-11-27T03:21:20Z</dcterms:modified>
</cp:coreProperties>
</file>